
<file path=[Content_Types].xml><?xml version="1.0" encoding="utf-8"?>
<Types xmlns="http://schemas.openxmlformats.org/package/2006/content-types">
  <Default Extension="jfif" ContentType="image/jpeg"/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  <p:sldId id="257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23" d="100"/>
          <a:sy n="123" d="100"/>
        </p:scale>
        <p:origin x="576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EF3F4E-D934-7BDC-A4EF-4844AEDED6F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6580E71-691A-B694-7924-6BDBDF4F122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1A6604A-58D0-EB8E-45C1-85117AE8B2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5B5F6-E683-4BF8-AC36-902EDFDDF1DE}" type="datetimeFigureOut">
              <a:rPr lang="en-US" smtClean="0"/>
              <a:t>4/19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89E373D-38A7-66E4-85EA-CD5CE2F85C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F34E597-C7FF-63B6-0561-96B6061D6D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59222-2E4F-440F-B22E-5F5D824259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17930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3CCD23-021D-A6E2-AE31-C80527E37E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FA9DD57-155E-00A5-6E05-2879629AC4E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34E423B-FC58-C69C-FEAB-6CAFBB0303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5B5F6-E683-4BF8-AC36-902EDFDDF1DE}" type="datetimeFigureOut">
              <a:rPr lang="en-US" smtClean="0"/>
              <a:t>4/19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C95F123-D61A-2732-8039-66563CC044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1A78CF3-42BD-947A-5C4E-31FF46D84D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59222-2E4F-440F-B22E-5F5D824259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90716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AA31A4A-3653-1655-650C-958D3CA0E0E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EE95DF8-4F47-9F9D-F14A-2568A5DDFA3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99ED900-D4CD-3E87-25A5-59C64E4A34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5B5F6-E683-4BF8-AC36-902EDFDDF1DE}" type="datetimeFigureOut">
              <a:rPr lang="en-US" smtClean="0"/>
              <a:t>4/19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4D64964-64EE-D1AD-BA62-A2B7009E20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57BD1CF-B26B-1E79-FE1B-B7F1EBE293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59222-2E4F-440F-B22E-5F5D824259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68538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DBFBF89-0DC1-C9EC-9C75-FDA34CDF3F4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07005B7-B0FA-2F69-DF92-2E99FB3EF9A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040209E-2ECB-D6D2-19B5-A5E6987C8F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5B5F6-E683-4BF8-AC36-902EDFDDF1DE}" type="datetimeFigureOut">
              <a:rPr lang="en-US" smtClean="0"/>
              <a:t>4/19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5579C2A-870D-3F3D-99C4-77438A8592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337E94F-036E-EC31-0329-8979FB5872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59222-2E4F-440F-B22E-5F5D824259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2842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51FF3F-1C94-A285-4CF0-6DEC023E03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B4D6D1C-D5C1-71F4-FE41-E1208095F8F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521AA26-41CA-9301-94B8-5870E19CFA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5B5F6-E683-4BF8-AC36-902EDFDDF1DE}" type="datetimeFigureOut">
              <a:rPr lang="en-US" smtClean="0"/>
              <a:t>4/19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173D648-C36E-D2DD-B9A4-1DF96C205B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3164562-DDC3-C3FD-5F31-1E181CAC2A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59222-2E4F-440F-B22E-5F5D824259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63037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EABBA12-AA4A-E777-5BFC-FB8A24BD7B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FC8560B-7784-063E-954A-AB9FB7DD9DF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94D0F7F-BB7C-29E0-E0F2-4AD06E6C20E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36DE6D4-ED67-5547-6678-9E29792CF3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5B5F6-E683-4BF8-AC36-902EDFDDF1DE}" type="datetimeFigureOut">
              <a:rPr lang="en-US" smtClean="0"/>
              <a:t>4/19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847AF0D-6B01-AC81-163C-09BAD9443A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6772AC2-C258-E007-8E28-F4434B79A7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59222-2E4F-440F-B22E-5F5D824259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39512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797195-76C1-31C4-21B6-0771A703F7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CCDFE86-9A73-89FE-58A2-C59915CA68C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805C7E5-79E6-AF2E-34F0-D501EA8A976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0DE55E7-5340-7796-B71C-488EE7E6E16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437137C-C7BA-808E-481F-28A112B4226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1DABF21-4920-72C8-3CB2-6ED3C424BB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5B5F6-E683-4BF8-AC36-902EDFDDF1DE}" type="datetimeFigureOut">
              <a:rPr lang="en-US" smtClean="0"/>
              <a:t>4/19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5CB2BDA-3AF2-F2E5-F463-52EF15E8BD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6AF0597-97C8-EFC2-C964-DA7E582F79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59222-2E4F-440F-B22E-5F5D824259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54514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B3D9BD-F1F6-332E-2B89-41E674CC376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4C736D3-5068-A4EE-2BD1-553AACA3D9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5B5F6-E683-4BF8-AC36-902EDFDDF1DE}" type="datetimeFigureOut">
              <a:rPr lang="en-US" smtClean="0"/>
              <a:t>4/19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D845A77-C6EE-E54C-8194-A5E1B6F418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38EC18C-9E87-B38B-200E-AE18A1CD84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59222-2E4F-440F-B22E-5F5D824259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98001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DD342CE-77BC-B9C8-EEDE-AAEB140EE3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5B5F6-E683-4BF8-AC36-902EDFDDF1DE}" type="datetimeFigureOut">
              <a:rPr lang="en-US" smtClean="0"/>
              <a:t>4/19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F6F198E-9333-0192-06A5-BB93BABE09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3A004F7-5FD8-4E2E-627A-1EF92FC410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59222-2E4F-440F-B22E-5F5D824259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69072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20C73CD-C072-E4DA-3A62-89DBFD4A8F8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87ECE3A-4372-41D1-18E6-CA53FA080DA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774E9B3-A84D-38C9-994D-01656BD0C37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446BBC2-434F-79FF-B03F-AB7076A517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5B5F6-E683-4BF8-AC36-902EDFDDF1DE}" type="datetimeFigureOut">
              <a:rPr lang="en-US" smtClean="0"/>
              <a:t>4/19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9A245CC-FFA9-744C-433D-A143D3542A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42DE3BA-E715-7CC0-FB3D-4D57633AA4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59222-2E4F-440F-B22E-5F5D824259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22827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9F5C39C-8956-4D42-6292-9D4D3EE019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07F38C0-4371-5E88-DFE4-466384E1DD5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C1F2179-220B-02D5-046E-AA00BCE6C1A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27F09F1-1214-1B2D-CAF5-DD592FE0D3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5B5F6-E683-4BF8-AC36-902EDFDDF1DE}" type="datetimeFigureOut">
              <a:rPr lang="en-US" smtClean="0"/>
              <a:t>4/19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A5EBF1A-36FB-738A-8D65-2080790D9E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32949A5-16F3-3CF0-3291-8B197B0B9A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59222-2E4F-440F-B22E-5F5D824259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88426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7206921-F0B0-9F71-8520-B042FC6EEB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1088B04-154A-174E-8EA9-BDAE8296212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B607BBE-4516-0033-58E5-F801CEDD957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85B5F6-E683-4BF8-AC36-902EDFDDF1DE}" type="datetimeFigureOut">
              <a:rPr lang="en-US" smtClean="0"/>
              <a:t>4/19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0EDC5FE-57B4-F2D8-8DBD-8F4D01E54DB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03377AC-23DB-5968-F917-04BE4C3775E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759222-2E4F-440F-B22E-5F5D824259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38602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fi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hest x-ray of a person&#10;&#10;Description automatically generated">
            <a:extLst>
              <a:ext uri="{FF2B5EF4-FFF2-40B4-BE49-F238E27FC236}">
                <a16:creationId xmlns:a16="http://schemas.microsoft.com/office/drawing/2014/main" id="{2430B68A-AEEA-299A-A0BD-1CCF5E3232E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38500" y="571500"/>
            <a:ext cx="5715000" cy="5715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0649783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CE6D0CE-B906-34EB-6F30-491595FEB6A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graph of a heart beat&#10;&#10;AI-generated content may be incorrect.">
            <a:extLst>
              <a:ext uri="{FF2B5EF4-FFF2-40B4-BE49-F238E27FC236}">
                <a16:creationId xmlns:a16="http://schemas.microsoft.com/office/drawing/2014/main" id="{99D10797-07CB-778A-2390-30CB6B2C597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455" y="370703"/>
            <a:ext cx="12115519" cy="612895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5074031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8501C9BB-A3CA-4B9A-48DE-7D765646E60A}"/>
              </a:ext>
            </a:extLst>
          </p:cNvPr>
          <p:cNvSpPr txBox="1"/>
          <p:nvPr/>
        </p:nvSpPr>
        <p:spPr>
          <a:xfrm>
            <a:off x="3794270" y="766732"/>
            <a:ext cx="4603459" cy="532453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2000" i="1" dirty="0"/>
              <a:t>Point of care lab values:</a:t>
            </a:r>
          </a:p>
          <a:p>
            <a:r>
              <a:rPr lang="en-US" sz="2000" dirty="0"/>
              <a:t>pH 		7.30</a:t>
            </a:r>
          </a:p>
          <a:p>
            <a:r>
              <a:rPr lang="en-US" sz="2000" dirty="0"/>
              <a:t>pCO2		37 mmHg</a:t>
            </a:r>
          </a:p>
          <a:p>
            <a:r>
              <a:rPr lang="en-US" sz="2000" dirty="0"/>
              <a:t>pO2 		75 mmHg</a:t>
            </a:r>
          </a:p>
          <a:p>
            <a:r>
              <a:rPr lang="en-US" sz="2000" dirty="0"/>
              <a:t>Total CO2 	17 </a:t>
            </a:r>
            <a:r>
              <a:rPr lang="en-US" sz="2000" dirty="0" err="1"/>
              <a:t>mEq</a:t>
            </a:r>
            <a:r>
              <a:rPr lang="en-US" sz="2000" dirty="0"/>
              <a:t>/L</a:t>
            </a:r>
          </a:p>
          <a:p>
            <a:r>
              <a:rPr lang="en-US" sz="2000" dirty="0"/>
              <a:t>Base excess 	-5.2 </a:t>
            </a:r>
            <a:r>
              <a:rPr lang="en-US" sz="2000" dirty="0" err="1"/>
              <a:t>mEq</a:t>
            </a:r>
            <a:r>
              <a:rPr lang="en-US" sz="2000" dirty="0"/>
              <a:t>/L</a:t>
            </a:r>
          </a:p>
          <a:p>
            <a:r>
              <a:rPr lang="en-US" sz="2000" dirty="0"/>
              <a:t>O2 saturation	90% </a:t>
            </a:r>
          </a:p>
          <a:p>
            <a:r>
              <a:rPr lang="en-US" sz="2000" dirty="0"/>
              <a:t>Sodium		135 </a:t>
            </a:r>
            <a:r>
              <a:rPr lang="en-US" sz="2000" dirty="0" err="1"/>
              <a:t>mEq</a:t>
            </a:r>
            <a:r>
              <a:rPr lang="en-US" sz="2000" dirty="0"/>
              <a:t>/L</a:t>
            </a:r>
          </a:p>
          <a:p>
            <a:r>
              <a:rPr lang="en-US" sz="2000" dirty="0"/>
              <a:t>Potassium	4.7 </a:t>
            </a:r>
            <a:r>
              <a:rPr lang="en-US" sz="2000" dirty="0" err="1"/>
              <a:t>mEq</a:t>
            </a:r>
            <a:r>
              <a:rPr lang="en-US" sz="2000" dirty="0"/>
              <a:t>/L</a:t>
            </a:r>
          </a:p>
          <a:p>
            <a:r>
              <a:rPr lang="en-US" sz="2000" dirty="0"/>
              <a:t>Ionized Calcium	3.0 (low) mg/dL</a:t>
            </a:r>
          </a:p>
          <a:p>
            <a:r>
              <a:rPr lang="en-US" sz="2000" dirty="0"/>
              <a:t>Chloride		98 </a:t>
            </a:r>
            <a:r>
              <a:rPr lang="en-US" sz="2000" dirty="0" err="1"/>
              <a:t>mEq</a:t>
            </a:r>
            <a:r>
              <a:rPr lang="en-US" sz="2000" dirty="0"/>
              <a:t>/L</a:t>
            </a:r>
          </a:p>
          <a:p>
            <a:r>
              <a:rPr lang="en-US" sz="2000" dirty="0"/>
              <a:t>Bicarbonate	18 </a:t>
            </a:r>
            <a:r>
              <a:rPr lang="en-US" sz="2000" dirty="0" err="1"/>
              <a:t>mEq</a:t>
            </a:r>
            <a:r>
              <a:rPr lang="en-US" sz="2000" dirty="0"/>
              <a:t>/L</a:t>
            </a:r>
          </a:p>
          <a:p>
            <a:r>
              <a:rPr lang="en-US" sz="2000" dirty="0"/>
              <a:t>Anion Gap	19 </a:t>
            </a:r>
            <a:r>
              <a:rPr lang="en-US" sz="2000" dirty="0" err="1"/>
              <a:t>mEq</a:t>
            </a:r>
            <a:r>
              <a:rPr lang="en-US" sz="2000" dirty="0"/>
              <a:t>/L</a:t>
            </a:r>
          </a:p>
          <a:p>
            <a:r>
              <a:rPr lang="en-US" sz="2000" dirty="0"/>
              <a:t>Hemoglobin	9.4 g/dL</a:t>
            </a:r>
          </a:p>
          <a:p>
            <a:r>
              <a:rPr lang="en-US" sz="2000" dirty="0"/>
              <a:t>Glucose		112 mg/dL</a:t>
            </a:r>
          </a:p>
          <a:p>
            <a:r>
              <a:rPr lang="en-US" sz="2000" dirty="0"/>
              <a:t>Lactate 		5 mmol/L</a:t>
            </a:r>
          </a:p>
          <a:p>
            <a:r>
              <a:rPr lang="en-US" sz="2000" dirty="0"/>
              <a:t>Creatinine</a:t>
            </a:r>
            <a:r>
              <a:rPr lang="en-US" sz="2000"/>
              <a:t>	2.2 </a:t>
            </a:r>
            <a:r>
              <a:rPr lang="en-US" sz="2000" dirty="0"/>
              <a:t>mg/dL</a:t>
            </a:r>
          </a:p>
        </p:txBody>
      </p:sp>
    </p:spTree>
    <p:extLst>
      <p:ext uri="{BB962C8B-B14F-4D97-AF65-F5344CB8AC3E}">
        <p14:creationId xmlns:p14="http://schemas.microsoft.com/office/powerpoint/2010/main" val="13486483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109</Words>
  <Application>Microsoft Macintosh PowerPoint</Application>
  <PresentationFormat>Widescreen</PresentationFormat>
  <Paragraphs>17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TTHEW HEFFERNAN</dc:creator>
  <cp:lastModifiedBy>Wray, Alisa</cp:lastModifiedBy>
  <cp:revision>2</cp:revision>
  <dcterms:created xsi:type="dcterms:W3CDTF">2024-04-18T05:09:16Z</dcterms:created>
  <dcterms:modified xsi:type="dcterms:W3CDTF">2025-04-19T20:13:42Z</dcterms:modified>
</cp:coreProperties>
</file>